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3" r:id="rId2"/>
    <p:sldId id="286" r:id="rId3"/>
    <p:sldId id="288" r:id="rId4"/>
    <p:sldId id="289" r:id="rId5"/>
    <p:sldId id="281" r:id="rId6"/>
    <p:sldId id="287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2558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6540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1881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9088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7265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335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4632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7888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956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8850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8355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9384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B48D6-02F7-4C62-AC4C-EB55C6217DF8}" type="datetimeFigureOut">
              <a:rPr lang="en-GB" smtClean="0"/>
              <a:t>05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4F378-2238-4FCF-BA96-10AD33A500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8463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93067C5-88E5-5875-5F23-FB46049006F1}"/>
              </a:ext>
            </a:extLst>
          </p:cNvPr>
          <p:cNvSpPr txBox="1"/>
          <p:nvPr/>
        </p:nvSpPr>
        <p:spPr>
          <a:xfrm>
            <a:off x="46300" y="369082"/>
            <a:ext cx="6765398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: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Expression levels of Nek2A and KIF2C in different patient datasets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ogFC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indicates the comparison of gene expression between responsive and non-responsive individuals against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axane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reatment. Data was accessed in Cancer Treatment Response Gene Signature Data Base (CTR-DB)</a:t>
            </a: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64B7D162-2B94-58A9-06A5-406721545EB6}"/>
              </a:ext>
            </a:extLst>
          </p:cNvPr>
          <p:cNvGraphicFramePr>
            <a:graphicFrameLocks noGrp="1"/>
          </p:cNvGraphicFramePr>
          <p:nvPr/>
        </p:nvGraphicFramePr>
        <p:xfrm>
          <a:off x="471487" y="807487"/>
          <a:ext cx="5915025" cy="3346438"/>
        </p:xfrm>
        <a:graphic>
          <a:graphicData uri="http://schemas.openxmlformats.org/drawingml/2006/table">
            <a:tbl>
              <a:tblPr/>
              <a:tblGrid>
                <a:gridCol w="1034634">
                  <a:extLst>
                    <a:ext uri="{9D8B030D-6E8A-4147-A177-3AD203B41FA5}">
                      <a16:colId xmlns:a16="http://schemas.microsoft.com/office/drawing/2014/main" val="462922913"/>
                    </a:ext>
                  </a:extLst>
                </a:gridCol>
                <a:gridCol w="979600">
                  <a:extLst>
                    <a:ext uri="{9D8B030D-6E8A-4147-A177-3AD203B41FA5}">
                      <a16:colId xmlns:a16="http://schemas.microsoft.com/office/drawing/2014/main" val="1398341700"/>
                    </a:ext>
                  </a:extLst>
                </a:gridCol>
                <a:gridCol w="1078661">
                  <a:extLst>
                    <a:ext uri="{9D8B030D-6E8A-4147-A177-3AD203B41FA5}">
                      <a16:colId xmlns:a16="http://schemas.microsoft.com/office/drawing/2014/main" val="3708198761"/>
                    </a:ext>
                  </a:extLst>
                </a:gridCol>
                <a:gridCol w="682418">
                  <a:extLst>
                    <a:ext uri="{9D8B030D-6E8A-4147-A177-3AD203B41FA5}">
                      <a16:colId xmlns:a16="http://schemas.microsoft.com/office/drawing/2014/main" val="6346465"/>
                    </a:ext>
                  </a:extLst>
                </a:gridCol>
                <a:gridCol w="416055">
                  <a:extLst>
                    <a:ext uri="{9D8B030D-6E8A-4147-A177-3AD203B41FA5}">
                      <a16:colId xmlns:a16="http://schemas.microsoft.com/office/drawing/2014/main" val="1459914155"/>
                    </a:ext>
                  </a:extLst>
                </a:gridCol>
                <a:gridCol w="653801">
                  <a:extLst>
                    <a:ext uri="{9D8B030D-6E8A-4147-A177-3AD203B41FA5}">
                      <a16:colId xmlns:a16="http://schemas.microsoft.com/office/drawing/2014/main" val="3665025367"/>
                    </a:ext>
                  </a:extLst>
                </a:gridCol>
                <a:gridCol w="416055">
                  <a:extLst>
                    <a:ext uri="{9D8B030D-6E8A-4147-A177-3AD203B41FA5}">
                      <a16:colId xmlns:a16="http://schemas.microsoft.com/office/drawing/2014/main" val="2280155836"/>
                    </a:ext>
                  </a:extLst>
                </a:gridCol>
                <a:gridCol w="653801">
                  <a:extLst>
                    <a:ext uri="{9D8B030D-6E8A-4147-A177-3AD203B41FA5}">
                      <a16:colId xmlns:a16="http://schemas.microsoft.com/office/drawing/2014/main" val="3285198741"/>
                    </a:ext>
                  </a:extLst>
                </a:gridCol>
              </a:tblGrid>
              <a:tr h="182001">
                <a:tc>
                  <a:txBody>
                    <a:bodyPr/>
                    <a:lstStyle/>
                    <a:p>
                      <a:pPr algn="ctr" fontAlgn="b"/>
                      <a:endParaRPr lang="en-GB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7" marR="6067" marT="606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7" marR="6067" marT="606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7" marR="6067" marT="606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67" marR="6067" marT="606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K2</a:t>
                      </a:r>
                    </a:p>
                  </a:txBody>
                  <a:tcPr marL="6067" marR="6067" marT="606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IF2C</a:t>
                      </a:r>
                    </a:p>
                  </a:txBody>
                  <a:tcPr marL="6067" marR="6067" marT="606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1310839"/>
                  </a:ext>
                </a:extLst>
              </a:tr>
              <a:tr h="1274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-DB ID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ncer Type</a:t>
                      </a:r>
                    </a:p>
                  </a:txBody>
                  <a:tcPr marL="6067" marR="6067" marT="606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rug</a:t>
                      </a:r>
                    </a:p>
                  </a:txBody>
                  <a:tcPr marL="6067" marR="6067" marT="606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mple size</a:t>
                      </a:r>
                    </a:p>
                  </a:txBody>
                  <a:tcPr marL="6067" marR="6067" marT="606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gFC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gFC-P value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gFC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gFC-P value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9171524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48</a:t>
                      </a:r>
                    </a:p>
                  </a:txBody>
                  <a:tcPr marL="6067" marR="6067" marT="606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3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9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5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0E-0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1144541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7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02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0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4298322"/>
                  </a:ext>
                </a:extLst>
              </a:tr>
              <a:tr h="139534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10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09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2112685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10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2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4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3375471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3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varian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0437409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2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2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3315736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40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2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01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3561995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7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4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823140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1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5317333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5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6010742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4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09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1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4836128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4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3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5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8834980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RNAseq_28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terine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4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1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6388316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7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varian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6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7592888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10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4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3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7856118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RNAseq_20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terine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9030894"/>
                  </a:ext>
                </a:extLst>
              </a:tr>
              <a:tr h="121334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RNAseq_11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ng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cli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9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3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6801233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107</a:t>
                      </a:r>
                    </a:p>
                  </a:txBody>
                  <a:tcPr marL="6067" marR="6067" marT="6067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ce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3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6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4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4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6745378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7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ce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4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4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7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8017441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ce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1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1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0569992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9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ce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07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3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6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9464218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6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ce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4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2973042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6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ce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3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03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9174952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9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ce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1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4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1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9388199"/>
                  </a:ext>
                </a:extLst>
              </a:tr>
              <a:tr h="115267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RNAseq_27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ft tissue tumours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ce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3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2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978785"/>
                  </a:ext>
                </a:extLst>
              </a:tr>
              <a:tr h="121334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R_Microarray_8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st cancer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cetaxel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15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09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</a:t>
                      </a:r>
                    </a:p>
                  </a:txBody>
                  <a:tcPr marL="6067" marR="6067" marT="6067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80530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967032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4E86E47-A72B-8469-39CB-6F4370F8A6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7093883"/>
              </p:ext>
            </p:extLst>
          </p:nvPr>
        </p:nvGraphicFramePr>
        <p:xfrm>
          <a:off x="941107" y="524691"/>
          <a:ext cx="5162551" cy="556260"/>
        </p:xfrm>
        <a:graphic>
          <a:graphicData uri="http://schemas.openxmlformats.org/drawingml/2006/table">
            <a:tbl>
              <a:tblPr/>
              <a:tblGrid>
                <a:gridCol w="1175278">
                  <a:extLst>
                    <a:ext uri="{9D8B030D-6E8A-4147-A177-3AD203B41FA5}">
                      <a16:colId xmlns:a16="http://schemas.microsoft.com/office/drawing/2014/main" val="3825917737"/>
                    </a:ext>
                  </a:extLst>
                </a:gridCol>
                <a:gridCol w="3987273">
                  <a:extLst>
                    <a:ext uri="{9D8B030D-6E8A-4147-A177-3AD203B41FA5}">
                      <a16:colId xmlns:a16="http://schemas.microsoft.com/office/drawing/2014/main" val="364845049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' - 3'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953934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K2_SDM_K37R-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 TGG CAA GAT ATT AGT TTG GAG AGA ACT TGA CTA TGG CTC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506144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K2_SDM_K37R-R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 CCA TAG TCA AGT TCT CTC CAA ACT AAT ATC TTG CCA TCA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24328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AA9935D-AB23-152A-3E14-ED98664DAA1B}"/>
              </a:ext>
            </a:extLst>
          </p:cNvPr>
          <p:cNvSpPr txBox="1"/>
          <p:nvPr/>
        </p:nvSpPr>
        <p:spPr>
          <a:xfrm>
            <a:off x="139683" y="180945"/>
            <a:ext cx="676539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: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Oligo sequences used for site-directed mutagenesis (SDM) reaction to generated Nek2A-(K37R) </a:t>
            </a:r>
          </a:p>
        </p:txBody>
      </p:sp>
    </p:spTree>
    <p:extLst>
      <p:ext uri="{BB962C8B-B14F-4D97-AF65-F5344CB8AC3E}">
        <p14:creationId xmlns:p14="http://schemas.microsoft.com/office/powerpoint/2010/main" val="8209001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E6C3431-6D1A-237F-0560-DDD8D1DABBA7}"/>
              </a:ext>
            </a:extLst>
          </p:cNvPr>
          <p:cNvGraphicFramePr>
            <a:graphicFrameLocks noGrp="1"/>
          </p:cNvGraphicFramePr>
          <p:nvPr/>
        </p:nvGraphicFramePr>
        <p:xfrm>
          <a:off x="1894114" y="792004"/>
          <a:ext cx="3200400" cy="1287780"/>
        </p:xfrm>
        <a:graphic>
          <a:graphicData uri="http://schemas.openxmlformats.org/drawingml/2006/table">
            <a:tbl>
              <a:tblPr/>
              <a:tblGrid>
                <a:gridCol w="1038497">
                  <a:extLst>
                    <a:ext uri="{9D8B030D-6E8A-4147-A177-3AD203B41FA5}">
                      <a16:colId xmlns:a16="http://schemas.microsoft.com/office/drawing/2014/main" val="3008746455"/>
                    </a:ext>
                  </a:extLst>
                </a:gridCol>
                <a:gridCol w="2161903">
                  <a:extLst>
                    <a:ext uri="{9D8B030D-6E8A-4147-A177-3AD203B41FA5}">
                      <a16:colId xmlns:a16="http://schemas.microsoft.com/office/drawing/2014/main" val="151588327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' - 3')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445592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k2-guide-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CGACATCGTTCGTTACTATGAT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112274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k2-guide-R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cATCATAGTAACGAACGATGTC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888678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otletin-guide-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CGAATGGCGAGCTCATCGCGCT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271609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otletin-guide-R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cAGCGCGATGAGCTCGCCATTC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902129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ap1-guide-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CGCGGCTGCAGAAGCTCACTG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456056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ap1-guide-R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cCAGTGAGCTTCTGCAGCCG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596597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05D4E18-F5CA-8FFC-DE4D-11157B087C3C}"/>
              </a:ext>
            </a:extLst>
          </p:cNvPr>
          <p:cNvSpPr txBox="1"/>
          <p:nvPr/>
        </p:nvSpPr>
        <p:spPr>
          <a:xfrm>
            <a:off x="1117019" y="403014"/>
            <a:ext cx="475458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: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Oligo sequences for sgRNA cloning into LentiCRISPR-v2 </a:t>
            </a:r>
          </a:p>
        </p:txBody>
      </p:sp>
    </p:spTree>
    <p:extLst>
      <p:ext uri="{BB962C8B-B14F-4D97-AF65-F5344CB8AC3E}">
        <p14:creationId xmlns:p14="http://schemas.microsoft.com/office/powerpoint/2010/main" val="33105698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B0558B4-A680-2F7E-3E25-E6DD8E81F000}"/>
              </a:ext>
            </a:extLst>
          </p:cNvPr>
          <p:cNvGraphicFramePr>
            <a:graphicFrameLocks noGrp="1"/>
          </p:cNvGraphicFramePr>
          <p:nvPr/>
        </p:nvGraphicFramePr>
        <p:xfrm>
          <a:off x="562247" y="692400"/>
          <a:ext cx="5733506" cy="556260"/>
        </p:xfrm>
        <a:graphic>
          <a:graphicData uri="http://schemas.openxmlformats.org/drawingml/2006/table">
            <a:tbl>
              <a:tblPr/>
              <a:tblGrid>
                <a:gridCol w="1151937">
                  <a:extLst>
                    <a:ext uri="{9D8B030D-6E8A-4147-A177-3AD203B41FA5}">
                      <a16:colId xmlns:a16="http://schemas.microsoft.com/office/drawing/2014/main" val="3446865974"/>
                    </a:ext>
                  </a:extLst>
                </a:gridCol>
                <a:gridCol w="4581569">
                  <a:extLst>
                    <a:ext uri="{9D8B030D-6E8A-4147-A177-3AD203B41FA5}">
                      <a16:colId xmlns:a16="http://schemas.microsoft.com/office/drawing/2014/main" val="1408329739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' - 3')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500713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KIF2C-CDS-F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GGGCCCGAATGATTAAAGAATTTCTCGAGAAATTCTTTAATCATTCGGGCTTTTTG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413439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KIF2C-CDS-R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TCAAAAAGCCCGAATGATTAAAGAATTTCTCGAGAAATTCTTTAATCATTCGGG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0766899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0D105C5-9729-1189-7E7A-E1F09C4E98D2}"/>
              </a:ext>
            </a:extLst>
          </p:cNvPr>
          <p:cNvSpPr txBox="1"/>
          <p:nvPr/>
        </p:nvSpPr>
        <p:spPr>
          <a:xfrm>
            <a:off x="1117019" y="403014"/>
            <a:ext cx="475458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: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Oligo sequences for shRNA cloning into Tet-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LK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629981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A7358C8C-7EEC-430E-0DAF-93347126C592}"/>
              </a:ext>
            </a:extLst>
          </p:cNvPr>
          <p:cNvGraphicFramePr>
            <a:graphicFrameLocks noGrp="1"/>
          </p:cNvGraphicFramePr>
          <p:nvPr/>
        </p:nvGraphicFramePr>
        <p:xfrm>
          <a:off x="2498271" y="698863"/>
          <a:ext cx="2057400" cy="1287780"/>
        </p:xfrm>
        <a:graphic>
          <a:graphicData uri="http://schemas.openxmlformats.org/drawingml/2006/table">
            <a:tbl>
              <a:tblPr/>
              <a:tblGrid>
                <a:gridCol w="622300">
                  <a:extLst>
                    <a:ext uri="{9D8B030D-6E8A-4147-A177-3AD203B41FA5}">
                      <a16:colId xmlns:a16="http://schemas.microsoft.com/office/drawing/2014/main" val="4217683686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3165912948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308431050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and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duct No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952416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k2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RCK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HU1099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533922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s2L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RCK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HU07887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296973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F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RCK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HU11482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695674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M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RCK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HU05914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963706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IFC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RCK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HU1480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60703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IF2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RCK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HU04621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9377931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DAC27D04-E7A9-8A79-CA82-A29612BDA05D}"/>
              </a:ext>
            </a:extLst>
          </p:cNvPr>
          <p:cNvSpPr txBox="1"/>
          <p:nvPr/>
        </p:nvSpPr>
        <p:spPr>
          <a:xfrm>
            <a:off x="1584452" y="344230"/>
            <a:ext cx="388503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5: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The list of siRNA products used in the study</a:t>
            </a:r>
          </a:p>
        </p:txBody>
      </p:sp>
    </p:spTree>
    <p:extLst>
      <p:ext uri="{BB962C8B-B14F-4D97-AF65-F5344CB8AC3E}">
        <p14:creationId xmlns:p14="http://schemas.microsoft.com/office/powerpoint/2010/main" val="2843912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D6A814E-87AD-5711-F873-7CD26C62564D}"/>
              </a:ext>
            </a:extLst>
          </p:cNvPr>
          <p:cNvGraphicFramePr>
            <a:graphicFrameLocks noGrp="1"/>
          </p:cNvGraphicFramePr>
          <p:nvPr/>
        </p:nvGraphicFramePr>
        <p:xfrm>
          <a:off x="1895078" y="741559"/>
          <a:ext cx="3167555" cy="3482340"/>
        </p:xfrm>
        <a:graphic>
          <a:graphicData uri="http://schemas.openxmlformats.org/drawingml/2006/table">
            <a:tbl>
              <a:tblPr/>
              <a:tblGrid>
                <a:gridCol w="771197">
                  <a:extLst>
                    <a:ext uri="{9D8B030D-6E8A-4147-A177-3AD203B41FA5}">
                      <a16:colId xmlns:a16="http://schemas.microsoft.com/office/drawing/2014/main" val="3362074786"/>
                    </a:ext>
                  </a:extLst>
                </a:gridCol>
                <a:gridCol w="2396358">
                  <a:extLst>
                    <a:ext uri="{9D8B030D-6E8A-4147-A177-3AD203B41FA5}">
                      <a16:colId xmlns:a16="http://schemas.microsoft.com/office/drawing/2014/main" val="374722118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' - 3')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869118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K2-F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 GAG CAG AAA GAA CAG GAG 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61648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K2-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 CCA CTG AAA TGA ACT TTC TT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082292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-F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 CCA TGG ATG ATG ATA TCG 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43018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-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A GGA ATC CTT CTG ACC CAT G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628413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-F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 ACT TCA ACA GCG ACA C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86267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-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 GTC ATA CCA GGA AAT GAG 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314332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K4-F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C CAA GGA CCT TAT TCA CC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518200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K4-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 GGC ATG CCC ACT ATC A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894389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F1-F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 CGC AGA GGC TAT TAT TCA TG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177398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F1-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 GCT GAT TCC AAG GGT G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525254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2L1-F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 ACG CTG GAG CAT TAC C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065877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2L1-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 AGA AAA GGT GCA GAC C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02576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ET-F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 GTA CTG CTC AGG CCA AC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245707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ET-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 AGC CCT GGG ACA TGG T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737273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a-F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 GTG GAA ACT AAT TCT AAG CCA 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879917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a-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 ACT CCA ATG CGC CTC C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10353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F2C-F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 GTT TCT CTT CCT TGC T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321189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F2C-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 TTG TGG CAC CTC CTT C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325363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69EEFEA-43A4-730C-E7BA-78BD10B3693B}"/>
              </a:ext>
            </a:extLst>
          </p:cNvPr>
          <p:cNvSpPr txBox="1"/>
          <p:nvPr/>
        </p:nvSpPr>
        <p:spPr>
          <a:xfrm>
            <a:off x="1724877" y="337699"/>
            <a:ext cx="350795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6: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T-qPCR primers used in this study</a:t>
            </a:r>
          </a:p>
        </p:txBody>
      </p:sp>
    </p:spTree>
    <p:extLst>
      <p:ext uri="{BB962C8B-B14F-4D97-AF65-F5344CB8AC3E}">
        <p14:creationId xmlns:p14="http://schemas.microsoft.com/office/powerpoint/2010/main" val="4001318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</TotalTime>
  <Words>766</Words>
  <Application>Microsoft Office PowerPoint</Application>
  <PresentationFormat>A4 Paper (210x297 mm)</PresentationFormat>
  <Paragraphs>30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TUHAN MERT KALKAN</dc:creator>
  <cp:lastModifiedBy>BATUHAN MERT KALKAN</cp:lastModifiedBy>
  <cp:revision>2</cp:revision>
  <dcterms:created xsi:type="dcterms:W3CDTF">2023-11-21T08:26:04Z</dcterms:created>
  <dcterms:modified xsi:type="dcterms:W3CDTF">2024-03-05T20:39:26Z</dcterms:modified>
</cp:coreProperties>
</file>